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28"/>
    <p:restoredTop sz="94516"/>
  </p:normalViewPr>
  <p:slideViewPr>
    <p:cSldViewPr snapToGrid="0" snapToObjects="1">
      <p:cViewPr varScale="1">
        <p:scale>
          <a:sx n="88" d="100"/>
          <a:sy n="88" d="100"/>
        </p:scale>
        <p:origin x="1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83C0E0-9222-B740-BE80-23C74C4911A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46B328-C2B6-3949-84E3-D05B5DD36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865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46B328-C2B6-3949-84E3-D05B5DD366A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9436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68487-AFCF-3145-851B-8B04D5F313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7C9199-AABC-1741-9AB9-199A277BC3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ECD83-348C-0549-B1A4-D21C9BD53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50682D-8095-9A47-AF58-82E5A2FC5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E081E4-2A7D-064F-AB00-A99ADAB75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406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CAD46-B31E-0A4C-892B-8F5F5FCEEE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258C34-FAE5-1743-9744-685449965A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5677EF-E4FE-0549-938E-4CF5B0370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152F7-508F-FC46-B682-AF125446A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5E51B0-F01F-974A-A0C4-C453B78E8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76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99A6EC-12AC-FC46-B8EC-247A52AE05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A4D1F2-A577-DD44-817D-853E002CED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EA212-FFA5-0C40-8FE1-2EE98039E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7968C7-C8BB-C94C-83A2-97CEF4166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D42F4-C73E-ED48-A280-1280F9123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114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5CDF1E-B36C-D54A-AF64-11E1A0202C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D66E1A-1C23-0B4F-82D4-3F36DC685C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EA1DD-C989-CE4A-8CF1-931D57958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B088D1-76C7-BF4A-948B-E2752DD0B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80B591-38EA-1C41-A80C-7248DF21F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886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67B94-1B3C-CA49-8393-41DF9BF6AE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61B9D2-75E2-C942-ACD1-3AA708FED2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9FE25E-01CA-8C47-AAEC-0EA0CC89B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9C2CBB-6C0D-3749-8912-037222F04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2955A-18B2-6043-9473-7AF07139A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719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EE22C2-1BBB-0945-8412-B1191B122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9958F5-F5EB-ED4D-A467-652D5288D1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DE3ED1-2F2B-C342-B78E-A52561E2DB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F93921-8A72-E948-B98F-1A639D965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352C16-C3B9-454F-BBAB-5C3DF0719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F333FE-7902-924F-95D1-674797BC8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108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04D2B-6A92-6645-B684-1E15944D6D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F0C372-16ED-A84D-9E72-87A4556A6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7793F5-D2B1-0C4E-9B74-9432DE6BBD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EA11EB-18BD-4E48-8C6E-8B5E71DA9C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98911D-AED4-4345-BC54-751BBBDE3C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41891D-450A-1C41-89E1-050222203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1FA4F5-0354-D346-9D34-C9F24C5CB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2AB2C9-F3AD-F446-9816-C51B52393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952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A1FED-9ABE-1B46-B0D0-CD685012C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F27C88-BB9F-4948-B994-D9C7C089E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7F6679-8A15-B64D-B31D-D5E511AC6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80399F-2F7E-E64A-8130-A0CC0F194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760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E8A9E0-E098-4948-A303-D387D48C3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B91202-FDF4-414E-8C3E-30E9EE98B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E59892-7770-9244-8959-04B9DD940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134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9F236-AAF2-C645-B6A2-E8F5BBF44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1A88EE-F79D-F44B-BC1B-EAC83EB296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A62AB6-F21C-CE41-9F17-7ED795E585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3F9061-03FB-7547-B18E-93624CC00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B74A8C-EE36-704D-937B-E9A50F37B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2BB523-23A9-B64D-8F0E-5E6B43257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497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75D72-ECDE-644C-AF86-33406429C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E032885-04B6-3B48-9E31-1AB0E727C3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D4658B-6C64-FA40-A26D-37B7D2ABA6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D42BD0-FDBB-2F4C-BC20-66F497416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1873A7-5420-154B-A83D-77683B57E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018C27-A52B-7D41-B4FC-DF716C2A3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133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52574A-A93D-734D-91F9-19FC9D522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FFAAF4-9247-7647-B169-C20ECCAF3F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56A68-E937-644F-84F9-5B5EAB7B08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73434-4A76-B941-85D3-B07CE8D65755}" type="datetimeFigureOut">
              <a:rPr lang="en-US" smtClean="0"/>
              <a:t>11/2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0785C-304F-9C43-960F-D375FD4AAA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D1973-2340-DB4E-999D-C85605D689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38688-B5AE-B546-BDAE-B07201A41F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208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9AA2F0C-F73F-8846-ADEF-07AE33736D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3015808"/>
              </p:ext>
            </p:extLst>
          </p:nvPr>
        </p:nvGraphicFramePr>
        <p:xfrm>
          <a:off x="179382" y="179920"/>
          <a:ext cx="5539930" cy="609804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511395">
                  <a:extLst>
                    <a:ext uri="{9D8B030D-6E8A-4147-A177-3AD203B41FA5}">
                      <a16:colId xmlns:a16="http://schemas.microsoft.com/office/drawing/2014/main" val="1564781321"/>
                    </a:ext>
                  </a:extLst>
                </a:gridCol>
                <a:gridCol w="370936">
                  <a:extLst>
                    <a:ext uri="{9D8B030D-6E8A-4147-A177-3AD203B41FA5}">
                      <a16:colId xmlns:a16="http://schemas.microsoft.com/office/drawing/2014/main" val="2279697701"/>
                    </a:ext>
                  </a:extLst>
                </a:gridCol>
                <a:gridCol w="603849">
                  <a:extLst>
                    <a:ext uri="{9D8B030D-6E8A-4147-A177-3AD203B41FA5}">
                      <a16:colId xmlns:a16="http://schemas.microsoft.com/office/drawing/2014/main" val="1057376664"/>
                    </a:ext>
                  </a:extLst>
                </a:gridCol>
                <a:gridCol w="1475117">
                  <a:extLst>
                    <a:ext uri="{9D8B030D-6E8A-4147-A177-3AD203B41FA5}">
                      <a16:colId xmlns:a16="http://schemas.microsoft.com/office/drawing/2014/main" val="3041498260"/>
                    </a:ext>
                  </a:extLst>
                </a:gridCol>
                <a:gridCol w="552091">
                  <a:extLst>
                    <a:ext uri="{9D8B030D-6E8A-4147-A177-3AD203B41FA5}">
                      <a16:colId xmlns:a16="http://schemas.microsoft.com/office/drawing/2014/main" val="3534362663"/>
                    </a:ext>
                  </a:extLst>
                </a:gridCol>
                <a:gridCol w="526211">
                  <a:extLst>
                    <a:ext uri="{9D8B030D-6E8A-4147-A177-3AD203B41FA5}">
                      <a16:colId xmlns:a16="http://schemas.microsoft.com/office/drawing/2014/main" val="2410645360"/>
                    </a:ext>
                  </a:extLst>
                </a:gridCol>
                <a:gridCol w="500331">
                  <a:extLst>
                    <a:ext uri="{9D8B030D-6E8A-4147-A177-3AD203B41FA5}">
                      <a16:colId xmlns:a16="http://schemas.microsoft.com/office/drawing/2014/main" val="615731970"/>
                    </a:ext>
                  </a:extLst>
                </a:gridCol>
              </a:tblGrid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 dirty="0">
                          <a:effectLst/>
                        </a:rPr>
                        <a:t>CD specificity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onjugat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lon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 dirty="0">
                          <a:effectLst/>
                        </a:rPr>
                        <a:t>Manufacturer, product number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os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Targe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las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05685653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PA-2.1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32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505221289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rCP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W264/5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4-96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285855547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-L1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37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4259984817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32D1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5-95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520537240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4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FIT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I3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48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4181142126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4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FIT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J4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ioLegend, 33670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4168595566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6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V4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FN5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ioLegend, 31092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891227338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6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FIT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FN5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ioLegend, 31090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053948633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9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VioBlu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DG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9-27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463384935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107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4A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8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006942427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112 (Nectin-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2.52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105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040840095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132 (IL-2 Rγ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AG18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90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040630689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152 (CTLA-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NI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7-68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051386225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18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Vio77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12G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103-79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868930483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23 (LAG-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EA35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105-45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53286936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26 (DNAM-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DX1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2-47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562944896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44 (2B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EA11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9-05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180707984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73 (PD-L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H1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806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2673300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74 (PD-L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H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792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478890099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279 (PD-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D1.3.1.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6-16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b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084381009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314 (NKG2D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1D1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794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370819085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317 (Tetherin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EA20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101-70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130241723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335 (NKp4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AP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9E2/NKp4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805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750628813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336 (NKp4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2.2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2-48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546898063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CD337 (NKp3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30-1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840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587878755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7H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AP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875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&amp;D Systems, FAB 714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637756000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LA-A,B,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AP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W6/3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ioLegend, 31141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048512140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C A/B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6D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835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503011713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ULBP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17081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R&amp;D Systems, FAB 1380P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Huma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769295897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AP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PC-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75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670467340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V4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PC-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ioLegend, 40015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634304422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FIT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PC-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74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071856485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PC-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932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726871682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G155-17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557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3496826114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rCP Cy5.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PC-2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D Biosciences, 55283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458292412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PEVio77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S43.1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6-63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2a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79710416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APC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5-21F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2-214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90617976"/>
                  </a:ext>
                </a:extLst>
              </a:tr>
              <a:tr h="19358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otyp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VioBlu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S5-21F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iltenyi Biotec, 130-094-670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Mou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IgG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2722428271"/>
                  </a:ext>
                </a:extLst>
              </a:tr>
              <a:tr h="9679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Zombi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NIR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Biolegend, 423106 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>
                          <a:effectLst/>
                        </a:rPr>
                        <a:t> 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500" dirty="0">
                          <a:effectLst/>
                        </a:rPr>
                        <a:t> 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081" marR="31081" marT="0" marB="0"/>
                </a:tc>
                <a:extLst>
                  <a:ext uri="{0D108BD9-81ED-4DB2-BD59-A6C34878D82A}">
                    <a16:rowId xmlns:a16="http://schemas.microsoft.com/office/drawing/2014/main" val="13246763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5BC69133-A3B3-BF45-A4F8-F407D35E8B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382" y="6441114"/>
            <a:ext cx="982126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1" i="0" u="none" strike="noStrike" cap="none" normalizeH="0" baseline="0" dirty="0">
                <a:ln>
                  <a:noFill/>
                </a:ln>
                <a:solidFill>
                  <a:srgbClr val="272727"/>
                </a:solidFill>
                <a:effectLst/>
                <a:latin typeface="Calibri Light" panose="020F030202020403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Supplementary Materials Table 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272727"/>
                </a:solidFill>
                <a:effectLst/>
                <a:latin typeface="Calibri Light" panose="020F030202020403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 Details of reagents, 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effectLst/>
                <a:latin typeface="Calibri Light" panose="020F030202020403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staining protocol (patient tumour and blood samples) and </a:t>
            </a:r>
            <a:r>
              <a:rPr kumimoji="0" lang="en-GB" altLang="en-US" sz="1100" b="0" i="0" u="none" strike="noStrike" cap="none" normalizeH="0" baseline="0" dirty="0" err="1">
                <a:ln>
                  <a:noFill/>
                </a:ln>
                <a:effectLst/>
                <a:latin typeface="Calibri Light" panose="020F030202020403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Cytoflex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effectLst/>
                <a:latin typeface="Calibri Light" panose="020F030202020403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 S laser configuration, for flow cytometric analysis.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11CEDCA-DEC5-6C42-9CA1-0DC7A55D2A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95615"/>
              </p:ext>
            </p:extLst>
          </p:nvPr>
        </p:nvGraphicFramePr>
        <p:xfrm>
          <a:off x="6204750" y="179920"/>
          <a:ext cx="1555618" cy="62179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55618">
                  <a:extLst>
                    <a:ext uri="{9D8B030D-6E8A-4147-A177-3AD203B41FA5}">
                      <a16:colId xmlns:a16="http://schemas.microsoft.com/office/drawing/2014/main" val="1749417796"/>
                    </a:ext>
                  </a:extLst>
                </a:gridCol>
              </a:tblGrid>
              <a:tr h="41099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ntibody staining protoc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2337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CD69-BV421</a:t>
                      </a:r>
                    </a:p>
                    <a:p>
                      <a:pPr algn="l"/>
                      <a:r>
                        <a:rPr lang="en-US" sz="1000" dirty="0"/>
                        <a:t>CD2- 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66822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CD9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88872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NKp30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08639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NKG2D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97498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DNAM1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97446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CD317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64385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2B4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58081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dirty="0"/>
                        <a:t>CD45-FITC</a:t>
                      </a:r>
                    </a:p>
                    <a:p>
                      <a:pPr algn="l"/>
                      <a:r>
                        <a:rPr lang="en-US" sz="1000" dirty="0"/>
                        <a:t>NKp46-APC</a:t>
                      </a:r>
                    </a:p>
                    <a:p>
                      <a:pPr algn="l"/>
                      <a:r>
                        <a:rPr lang="en-US" sz="1000" dirty="0"/>
                        <a:t>CD3-PerCP</a:t>
                      </a:r>
                    </a:p>
                    <a:p>
                      <a:pPr algn="l"/>
                      <a:r>
                        <a:rPr lang="en-US" sz="1000" dirty="0"/>
                        <a:t>PD1-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8668807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1F8B50C-CF58-0240-A9F3-937D56A91D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8209053"/>
              </p:ext>
            </p:extLst>
          </p:nvPr>
        </p:nvGraphicFramePr>
        <p:xfrm>
          <a:off x="8245806" y="609600"/>
          <a:ext cx="3348037" cy="465220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27050">
                  <a:extLst>
                    <a:ext uri="{9D8B030D-6E8A-4147-A177-3AD203B41FA5}">
                      <a16:colId xmlns:a16="http://schemas.microsoft.com/office/drawing/2014/main" val="3346090639"/>
                    </a:ext>
                  </a:extLst>
                </a:gridCol>
                <a:gridCol w="612775">
                  <a:extLst>
                    <a:ext uri="{9D8B030D-6E8A-4147-A177-3AD203B41FA5}">
                      <a16:colId xmlns:a16="http://schemas.microsoft.com/office/drawing/2014/main" val="1419658468"/>
                    </a:ext>
                  </a:extLst>
                </a:gridCol>
                <a:gridCol w="527050">
                  <a:extLst>
                    <a:ext uri="{9D8B030D-6E8A-4147-A177-3AD203B41FA5}">
                      <a16:colId xmlns:a16="http://schemas.microsoft.com/office/drawing/2014/main" val="471408115"/>
                    </a:ext>
                  </a:extLst>
                </a:gridCol>
                <a:gridCol w="661987">
                  <a:extLst>
                    <a:ext uri="{9D8B030D-6E8A-4147-A177-3AD203B41FA5}">
                      <a16:colId xmlns:a16="http://schemas.microsoft.com/office/drawing/2014/main" val="4090191210"/>
                    </a:ext>
                  </a:extLst>
                </a:gridCol>
                <a:gridCol w="509587">
                  <a:extLst>
                    <a:ext uri="{9D8B030D-6E8A-4147-A177-3AD203B41FA5}">
                      <a16:colId xmlns:a16="http://schemas.microsoft.com/office/drawing/2014/main" val="2097416486"/>
                    </a:ext>
                  </a:extLst>
                </a:gridCol>
                <a:gridCol w="509588">
                  <a:extLst>
                    <a:ext uri="{9D8B030D-6E8A-4147-A177-3AD203B41FA5}">
                      <a16:colId xmlns:a16="http://schemas.microsoft.com/office/drawing/2014/main" val="3038827934"/>
                    </a:ext>
                  </a:extLst>
                </a:gridCol>
              </a:tblGrid>
              <a:tr h="3195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Excitation </a:t>
                      </a:r>
                    </a:p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Laser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 dirty="0">
                          <a:effectLst/>
                        </a:rPr>
                        <a:t>Excitation </a:t>
                      </a:r>
                    </a:p>
                    <a:p>
                      <a:pPr algn="ctr" fontAlgn="ctr"/>
                      <a:r>
                        <a:rPr lang="en-GB" sz="900" u="none" strike="noStrike" dirty="0">
                          <a:effectLst/>
                        </a:rPr>
                        <a:t>Wavelength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 dirty="0">
                          <a:effectLst/>
                        </a:rPr>
                        <a:t>Excitation </a:t>
                      </a:r>
                    </a:p>
                    <a:p>
                      <a:pPr algn="ctr" fontAlgn="ctr"/>
                      <a:r>
                        <a:rPr lang="en-GB" sz="900" u="none" strike="noStrike" dirty="0">
                          <a:effectLst/>
                        </a:rPr>
                        <a:t>Power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Fluorescenc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 dirty="0">
                          <a:effectLst/>
                        </a:rPr>
                        <a:t>Bandpass </a:t>
                      </a:r>
                    </a:p>
                    <a:p>
                      <a:pPr algn="ctr" fontAlgn="ctr"/>
                      <a:r>
                        <a:rPr lang="en-GB" sz="900" u="none" strike="noStrike" dirty="0">
                          <a:effectLst/>
                        </a:rPr>
                        <a:t>Filter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Dy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78682442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lu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88n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0mW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lue Scatte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/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/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11004852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lu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lue Scatte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88/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/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44154329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lu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Gree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525/4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FIT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43008658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lu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rang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85/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P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54817700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lu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range/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10/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PE-Tx R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65262372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lu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90/5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PE-Cy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81767675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lu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IR/Far 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80/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PE-Cy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86318671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Viole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05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Viole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50/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V4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33426512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Viole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05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Gree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25/4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BV5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70322240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Viole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05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range/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10/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V60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06496805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U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75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Viole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50/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UV39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87462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U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75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ar 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75/3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BUV73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68667567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3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60/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AP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52373868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Re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3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Red/I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12/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AF70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78317175"/>
                  </a:ext>
                </a:extLst>
              </a:tr>
              <a:tr h="2888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R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38n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0m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IR/Far R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80/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APC-Cy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256244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9572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6</TotalTime>
  <Words>623</Words>
  <Application>Microsoft Macintosh PowerPoint</Application>
  <PresentationFormat>Widescreen</PresentationFormat>
  <Paragraphs>4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a Watson</dc:creator>
  <cp:lastModifiedBy>Erica Watson</cp:lastModifiedBy>
  <cp:revision>9</cp:revision>
  <dcterms:created xsi:type="dcterms:W3CDTF">2019-04-26T16:18:36Z</dcterms:created>
  <dcterms:modified xsi:type="dcterms:W3CDTF">2019-11-21T14:12:43Z</dcterms:modified>
</cp:coreProperties>
</file>